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C23C600-C9CD-CB4A-9869-7787D4C74FB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395" t="28070" r="14200" b="23715"/>
          <a:stretch/>
        </p:blipFill>
        <p:spPr>
          <a:xfrm>
            <a:off x="768400" y="5028635"/>
            <a:ext cx="3165762" cy="166977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0055CCE-F6B4-9641-8C37-C6D202AD9D3A}"/>
              </a:ext>
            </a:extLst>
          </p:cNvPr>
          <p:cNvSpPr txBox="1"/>
          <p:nvPr/>
        </p:nvSpPr>
        <p:spPr>
          <a:xfrm>
            <a:off x="1106078" y="4532259"/>
            <a:ext cx="881126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ASPC1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C8E28F0-B59F-EF47-AB06-34B43630913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661" t="47958" r="19594" b="36219"/>
          <a:stretch/>
        </p:blipFill>
        <p:spPr>
          <a:xfrm>
            <a:off x="758218" y="6850514"/>
            <a:ext cx="3174597" cy="5188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E87F39E-0245-D242-9C60-A462E93D2877}"/>
              </a:ext>
            </a:extLst>
          </p:cNvPr>
          <p:cNvSpPr txBox="1"/>
          <p:nvPr/>
        </p:nvSpPr>
        <p:spPr>
          <a:xfrm>
            <a:off x="1126832" y="4749188"/>
            <a:ext cx="388248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1BDA9B-4E84-C346-864C-2FD5BD8FF7A8}"/>
              </a:ext>
            </a:extLst>
          </p:cNvPr>
          <p:cNvSpPr txBox="1"/>
          <p:nvPr/>
        </p:nvSpPr>
        <p:spPr>
          <a:xfrm>
            <a:off x="1402960" y="4749188"/>
            <a:ext cx="343364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4C0D7E-DC81-DB47-B093-7C2CE698CC5D}"/>
              </a:ext>
            </a:extLst>
          </p:cNvPr>
          <p:cNvSpPr txBox="1"/>
          <p:nvPr/>
        </p:nvSpPr>
        <p:spPr>
          <a:xfrm>
            <a:off x="1739651" y="4749188"/>
            <a:ext cx="343364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0C0C77-BEDB-F546-9AC8-A960C5D2BA6B}"/>
              </a:ext>
            </a:extLst>
          </p:cNvPr>
          <p:cNvSpPr txBox="1"/>
          <p:nvPr/>
        </p:nvSpPr>
        <p:spPr>
          <a:xfrm>
            <a:off x="300324" y="5854706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CEC6601-88E9-D542-AA7A-D3B7F8302998}"/>
              </a:ext>
            </a:extLst>
          </p:cNvPr>
          <p:cNvSpPr txBox="1"/>
          <p:nvPr/>
        </p:nvSpPr>
        <p:spPr>
          <a:xfrm>
            <a:off x="189189" y="6992226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00F0762-A37F-C0D8-2FBC-93E069BE7E6C}"/>
              </a:ext>
            </a:extLst>
          </p:cNvPr>
          <p:cNvSpPr/>
          <p:nvPr/>
        </p:nvSpPr>
        <p:spPr>
          <a:xfrm>
            <a:off x="1022464" y="5854706"/>
            <a:ext cx="1053552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552EC42-3863-2750-FE8E-EC0A842E20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288" t="20473" r="10478" b="27284"/>
          <a:stretch/>
        </p:blipFill>
        <p:spPr>
          <a:xfrm>
            <a:off x="779927" y="1376177"/>
            <a:ext cx="3157523" cy="165484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394A11B3-8267-FC0E-EB2E-ED4BADCD836C}"/>
              </a:ext>
            </a:extLst>
          </p:cNvPr>
          <p:cNvSpPr txBox="1"/>
          <p:nvPr/>
        </p:nvSpPr>
        <p:spPr>
          <a:xfrm>
            <a:off x="1064254" y="864872"/>
            <a:ext cx="906780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TU8988S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6A143AC1-0092-722C-13E1-28BF8047AEF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111" t="42884" r="12716" b="40282"/>
          <a:stretch/>
        </p:blipFill>
        <p:spPr>
          <a:xfrm>
            <a:off x="776638" y="3183127"/>
            <a:ext cx="3157523" cy="518875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01AA588-C795-0DCA-FBF1-B9DBE12E0987}"/>
              </a:ext>
            </a:extLst>
          </p:cNvPr>
          <p:cNvSpPr txBox="1"/>
          <p:nvPr/>
        </p:nvSpPr>
        <p:spPr>
          <a:xfrm>
            <a:off x="1027769" y="1091918"/>
            <a:ext cx="612556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17B7538-3618-6EA6-1AB6-1DCB02CE6456}"/>
              </a:ext>
            </a:extLst>
          </p:cNvPr>
          <p:cNvSpPr txBox="1"/>
          <p:nvPr/>
        </p:nvSpPr>
        <p:spPr>
          <a:xfrm>
            <a:off x="1353827" y="1091918"/>
            <a:ext cx="343364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A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4E5D636-1409-1936-4399-96AFC37683B4}"/>
              </a:ext>
            </a:extLst>
          </p:cNvPr>
          <p:cNvSpPr txBox="1"/>
          <p:nvPr/>
        </p:nvSpPr>
        <p:spPr>
          <a:xfrm>
            <a:off x="1736274" y="1091918"/>
            <a:ext cx="343364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47D873C-8667-240E-314D-CA70D8D508F2}"/>
              </a:ext>
            </a:extLst>
          </p:cNvPr>
          <p:cNvSpPr txBox="1"/>
          <p:nvPr/>
        </p:nvSpPr>
        <p:spPr>
          <a:xfrm>
            <a:off x="144312" y="3324840"/>
            <a:ext cx="588623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5EF523B-7896-3747-C46C-1AA5C7C68323}"/>
              </a:ext>
            </a:extLst>
          </p:cNvPr>
          <p:cNvSpPr txBox="1"/>
          <p:nvPr/>
        </p:nvSpPr>
        <p:spPr>
          <a:xfrm>
            <a:off x="182831" y="2168368"/>
            <a:ext cx="486030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D9C6E75-1974-35A7-C708-715A94AC38DD}"/>
              </a:ext>
            </a:extLst>
          </p:cNvPr>
          <p:cNvSpPr/>
          <p:nvPr/>
        </p:nvSpPr>
        <p:spPr>
          <a:xfrm>
            <a:off x="1144962" y="2114533"/>
            <a:ext cx="1012658" cy="268994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D762CF-66F6-1A76-5C42-F57E023413D7}"/>
              </a:ext>
            </a:extLst>
          </p:cNvPr>
          <p:cNvSpPr txBox="1"/>
          <p:nvPr/>
        </p:nvSpPr>
        <p:spPr>
          <a:xfrm>
            <a:off x="2201829" y="1114855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2F48E23-E17B-78F2-6BD3-52890E44311E}"/>
              </a:ext>
            </a:extLst>
          </p:cNvPr>
          <p:cNvSpPr txBox="1"/>
          <p:nvPr/>
        </p:nvSpPr>
        <p:spPr>
          <a:xfrm>
            <a:off x="2241685" y="2161360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AC8289F-C970-FBC0-5749-BFD199E4D5AF}"/>
              </a:ext>
            </a:extLst>
          </p:cNvPr>
          <p:cNvSpPr txBox="1"/>
          <p:nvPr/>
        </p:nvSpPr>
        <p:spPr>
          <a:xfrm>
            <a:off x="2178326" y="3344460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A4B4695-98E9-ECCC-CD9D-F8D3F6E912E1}"/>
              </a:ext>
            </a:extLst>
          </p:cNvPr>
          <p:cNvSpPr txBox="1"/>
          <p:nvPr/>
        </p:nvSpPr>
        <p:spPr>
          <a:xfrm>
            <a:off x="2159066" y="4786781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111E2B4-76E8-04C3-E357-7F5E11C227F1}"/>
              </a:ext>
            </a:extLst>
          </p:cNvPr>
          <p:cNvSpPr txBox="1"/>
          <p:nvPr/>
        </p:nvSpPr>
        <p:spPr>
          <a:xfrm>
            <a:off x="2198922" y="5833285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7629D17-CCE6-EFE1-AB3D-65DDD3A21AB9}"/>
              </a:ext>
            </a:extLst>
          </p:cNvPr>
          <p:cNvSpPr txBox="1"/>
          <p:nvPr/>
        </p:nvSpPr>
        <p:spPr>
          <a:xfrm>
            <a:off x="2135563" y="7016385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6AE486F-24E5-F003-BA3C-17E76CE0BD0F}"/>
              </a:ext>
            </a:extLst>
          </p:cNvPr>
          <p:cNvSpPr/>
          <p:nvPr/>
        </p:nvSpPr>
        <p:spPr>
          <a:xfrm>
            <a:off x="1102308" y="3308066"/>
            <a:ext cx="1012658" cy="268994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447DCDA-F7E3-2D95-C214-85ED593AC2FE}"/>
              </a:ext>
            </a:extLst>
          </p:cNvPr>
          <p:cNvSpPr/>
          <p:nvPr/>
        </p:nvSpPr>
        <p:spPr>
          <a:xfrm>
            <a:off x="1019865" y="6954643"/>
            <a:ext cx="1053552" cy="27137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74FCC5-C423-D277-3830-421301A7D46D}"/>
              </a:ext>
            </a:extLst>
          </p:cNvPr>
          <p:cNvSpPr txBox="1"/>
          <p:nvPr/>
        </p:nvSpPr>
        <p:spPr>
          <a:xfrm>
            <a:off x="209904" y="166613"/>
            <a:ext cx="6434775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Figure 3a.</a:t>
            </a:r>
          </a:p>
        </p:txBody>
      </p:sp>
    </p:spTree>
    <p:extLst>
      <p:ext uri="{BB962C8B-B14F-4D97-AF65-F5344CB8AC3E}">
        <p14:creationId xmlns:p14="http://schemas.microsoft.com/office/powerpoint/2010/main" val="1564881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33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4:08Z</dcterms:modified>
</cp:coreProperties>
</file>